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2" r:id="rId6"/>
    <p:sldId id="260" r:id="rId7"/>
    <p:sldId id="264" r:id="rId8"/>
    <p:sldId id="265" r:id="rId9"/>
    <p:sldId id="261" r:id="rId10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0440" autoAdjust="0"/>
    <p:restoredTop sz="94660"/>
  </p:normalViewPr>
  <p:slideViewPr>
    <p:cSldViewPr>
      <p:cViewPr>
        <p:scale>
          <a:sx n="50" d="100"/>
          <a:sy n="50" d="100"/>
        </p:scale>
        <p:origin x="-2208" y="-4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691B0-0676-4D43-B906-0E3E323E8914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42644-1CF7-4983-AB36-0C37FFA7C5A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691B0-0676-4D43-B906-0E3E323E8914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42644-1CF7-4983-AB36-0C37FFA7C5A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691B0-0676-4D43-B906-0E3E323E8914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42644-1CF7-4983-AB36-0C37FFA7C5A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691B0-0676-4D43-B906-0E3E323E8914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42644-1CF7-4983-AB36-0C37FFA7C5A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691B0-0676-4D43-B906-0E3E323E8914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42644-1CF7-4983-AB36-0C37FFA7C5A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691B0-0676-4D43-B906-0E3E323E8914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42644-1CF7-4983-AB36-0C37FFA7C5A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691B0-0676-4D43-B906-0E3E323E8914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42644-1CF7-4983-AB36-0C37FFA7C5A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691B0-0676-4D43-B906-0E3E323E8914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42644-1CF7-4983-AB36-0C37FFA7C5A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691B0-0676-4D43-B906-0E3E323E8914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42644-1CF7-4983-AB36-0C37FFA7C5A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691B0-0676-4D43-B906-0E3E323E8914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42644-1CF7-4983-AB36-0C37FFA7C5A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691B0-0676-4D43-B906-0E3E323E8914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42644-1CF7-4983-AB36-0C37FFA7C5A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691B0-0676-4D43-B906-0E3E323E8914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642644-1CF7-4983-AB36-0C37FFA7C5A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52400" y="76200"/>
            <a:ext cx="410189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S3A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Regulation of </a:t>
            </a:r>
            <a:r>
              <a:rPr lang="en-US" sz="1600" b="1" dirty="0" err="1" smtClean="0">
                <a:latin typeface="Times New Roman" pitchFamily="18" charset="0"/>
                <a:cs typeface="Times New Roman" pitchFamily="18" charset="0"/>
              </a:rPr>
              <a:t>actin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cytoskeleton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 descr="KEGG network_Actin cytoskeleton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143000" y="423738"/>
            <a:ext cx="5486400" cy="4453062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76200" y="4953000"/>
            <a:ext cx="377488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S3B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Calcium signaling pathway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" name="Picture 8" descr="KEGG network_Calcium Signaling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066800" y="5300538"/>
            <a:ext cx="5486400" cy="4453062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6200" y="76200"/>
            <a:ext cx="356809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S3C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MAPK signaling pathway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 descr="KEGG network_MAPK signaling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066800" y="425654"/>
            <a:ext cx="5486400" cy="4453062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76200" y="4919538"/>
            <a:ext cx="420563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S3D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T cell receptor signaling pathway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Picture 6" descr="KEGG network_T-cell receptor signaling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066800" y="5300538"/>
            <a:ext cx="5486400" cy="4453062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6200" y="76200"/>
            <a:ext cx="61722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600" b="1" smtClean="0">
                <a:latin typeface="Times New Roman" pitchFamily="18" charset="0"/>
                <a:cs typeface="Times New Roman" pitchFamily="18" charset="0"/>
              </a:rPr>
              <a:t>S3E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Cytokine-cytokine receptor interaction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Picture 5" descr="KEGG network_cytokine-cytokine receptor interaction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143000" y="457200"/>
            <a:ext cx="5486400" cy="4453062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152400" y="4964668"/>
            <a:ext cx="380636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S3F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600" b="1" dirty="0" err="1" smtClean="0">
                <a:latin typeface="Times New Roman" pitchFamily="18" charset="0"/>
                <a:cs typeface="Times New Roman" pitchFamily="18" charset="0"/>
              </a:rPr>
              <a:t>Jak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-STAT signaling pathway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" name="Picture 8" descr="KEGG network_Jak Stat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143000" y="5300538"/>
            <a:ext cx="5486400" cy="4453062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6200" y="76200"/>
            <a:ext cx="484036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S3G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Natural Killer cell mediated </a:t>
            </a:r>
            <a:r>
              <a:rPr lang="en-US" sz="1600" b="1" dirty="0" err="1" smtClean="0">
                <a:latin typeface="Times New Roman" pitchFamily="18" charset="0"/>
                <a:cs typeface="Times New Roman" pitchFamily="18" charset="0"/>
              </a:rPr>
              <a:t>cytotoxicity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76200" y="4812268"/>
            <a:ext cx="416921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3H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600" b="1" dirty="0" err="1" smtClean="0">
                <a:latin typeface="Times New Roman" pitchFamily="18" charset="0"/>
                <a:cs typeface="Times New Roman" pitchFamily="18" charset="0"/>
              </a:rPr>
              <a:t>Fc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epsilon RI signaling pathway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Picture 5" descr="KEGG network_Fc epsilon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3000" y="5301697"/>
            <a:ext cx="5486400" cy="4451903"/>
          </a:xfrm>
          <a:prstGeom prst="rect">
            <a:avLst/>
          </a:prstGeom>
        </p:spPr>
      </p:pic>
      <p:pic>
        <p:nvPicPr>
          <p:cNvPr id="7" name="Picture 6" descr="KEGG network_Natural Killer mediated cytotoxicity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143000" y="381000"/>
            <a:ext cx="5486400" cy="4453062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6200" y="76200"/>
            <a:ext cx="414023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S3I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600" b="1" dirty="0" err="1" smtClean="0">
                <a:latin typeface="Times New Roman" pitchFamily="18" charset="0"/>
                <a:cs typeface="Times New Roman" pitchFamily="18" charset="0"/>
              </a:rPr>
              <a:t>Adipocytokine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signaling pathway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 descr="KEGG network_Adipokine signling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143000" y="488270"/>
            <a:ext cx="5486400" cy="4453062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76200" y="4919538"/>
            <a:ext cx="307436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S3J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Cell Communication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Picture 6" descr="KEGG network_Cell communication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066800" y="5300538"/>
            <a:ext cx="5486400" cy="4453062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76200" y="152400"/>
            <a:ext cx="261751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S3K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Focal adhesion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Picture 6" descr="KEGG network_Focal Adhesion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143000" y="457200"/>
            <a:ext cx="5486400" cy="4453062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76200" y="4768334"/>
            <a:ext cx="244599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S3L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Gap junction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" name="Picture 8" descr="KEGG network_Gap Junction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143000" y="5224338"/>
            <a:ext cx="5486400" cy="4453062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6200" y="4953000"/>
            <a:ext cx="330359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3N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Fatty acid metabolism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 descr="KEGG network_Fatty acid metabolism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066800" y="5365070"/>
            <a:ext cx="5486400" cy="4453062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76200" y="76200"/>
            <a:ext cx="277608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S3M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VEGF Signaling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Picture 6" descr="KEGG network_VEGF signaling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3000" y="489429"/>
            <a:ext cx="5486400" cy="4451903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52400" y="76200"/>
            <a:ext cx="357129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S3O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Insulin signaling pathway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 descr="KEGG network_Insulin Receptor signaling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143000" y="488270"/>
            <a:ext cx="5486400" cy="4453062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76200" y="4995738"/>
            <a:ext cx="378238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S3P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TGF-beta signaling pathway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" name="Picture 8" descr="KEGG network_TGF beta signaling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143000" y="5300538"/>
            <a:ext cx="5486400" cy="4453062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KEGG network_WNT signaling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066800" y="381000"/>
            <a:ext cx="5486400" cy="4453062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76200" y="76200"/>
            <a:ext cx="333835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S3Q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600" b="1" dirty="0" err="1" smtClean="0">
                <a:latin typeface="Times New Roman" pitchFamily="18" charset="0"/>
                <a:cs typeface="Times New Roman" pitchFamily="18" charset="0"/>
              </a:rPr>
              <a:t>Wnt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signaling pathway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76200" y="4972878"/>
            <a:ext cx="64008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S3R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600" b="1" dirty="0" err="1" smtClean="0">
                <a:latin typeface="Times New Roman" pitchFamily="18" charset="0"/>
                <a:cs typeface="Times New Roman" pitchFamily="18" charset="0"/>
              </a:rPr>
              <a:t>Neuroactive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600" b="1" dirty="0" err="1" smtClean="0">
                <a:latin typeface="Times New Roman" pitchFamily="18" charset="0"/>
                <a:cs typeface="Times New Roman" pitchFamily="18" charset="0"/>
              </a:rPr>
              <a:t>ligand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-receptor interaction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Picture 6" descr="KEGG network_Neuroactive Ligand interaction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066800" y="5378894"/>
            <a:ext cx="5486400" cy="4450906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111</Words>
  <Application>Microsoft Office PowerPoint</Application>
  <PresentationFormat>A4 Paper (210x297 mm)</PresentationFormat>
  <Paragraphs>18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</vt:vector>
  </TitlesOfParts>
  <Company> 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 </dc:creator>
  <cp:lastModifiedBy> </cp:lastModifiedBy>
  <cp:revision>6</cp:revision>
  <dcterms:created xsi:type="dcterms:W3CDTF">2013-09-18T08:10:33Z</dcterms:created>
  <dcterms:modified xsi:type="dcterms:W3CDTF">2013-12-17T04:32:48Z</dcterms:modified>
</cp:coreProperties>
</file>